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78" r:id="rId2"/>
  </p:sldIdLst>
  <p:sldSz cx="6858000" cy="9144000" type="letter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6DFF00"/>
    <a:srgbClr val="FFFF00"/>
    <a:srgbClr val="171717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04" autoAdjust="0"/>
    <p:restoredTop sz="78818" autoAdjust="0"/>
  </p:normalViewPr>
  <p:slideViewPr>
    <p:cSldViewPr snapToGrid="0">
      <p:cViewPr varScale="1">
        <p:scale>
          <a:sx n="70" d="100"/>
          <a:sy n="70" d="100"/>
        </p:scale>
        <p:origin x="4792" y="1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3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r">
              <a:defRPr sz="1200"/>
            </a:lvl1pPr>
          </a:lstStyle>
          <a:p>
            <a:fld id="{E92D1EB7-785E-4EC2-902A-935C806FE68F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1" tIns="47111" rIns="94221" bIns="4711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3"/>
            <a:ext cx="5681980" cy="3696713"/>
          </a:xfrm>
          <a:prstGeom prst="rect">
            <a:avLst/>
          </a:prstGeom>
        </p:spPr>
        <p:txBody>
          <a:bodyPr vert="horz" lIns="94221" tIns="47111" rIns="94221" bIns="4711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3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r">
              <a:defRPr sz="1200"/>
            </a:lvl1pPr>
          </a:lstStyle>
          <a:p>
            <a:fld id="{122F76DF-B0D4-4C7B-A882-555C14374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3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l">
              <a:lnSpc>
                <a:spcPts val="13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i="0" dirty="0">
                <a:solidFill>
                  <a:srgbClr val="734126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ree-dimensional segmentation in Amira for MERCS identification. (a) Segmentation and 3D rendering of ER (yellow), mitochondria (b, green), and Mito-ER segmentation (c) to generate MERCS surfaces (d, pink). (e) Measuring MERCS morphology using label analysis measurements to determine volume, length, and MERCS coverage per mitochondrial perimeter.</a:t>
            </a:r>
            <a:r>
              <a:rPr lang="en-US" dirty="0">
                <a:effectLst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b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2F76DF-B0D4-4C7B-A882-555C143747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951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1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4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363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65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04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44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427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038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56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8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36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663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171717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504ACCB-0217-6B32-B41E-816FED6326C6}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164"/>
          <a:stretch/>
        </p:blipFill>
        <p:spPr>
          <a:xfrm>
            <a:off x="0" y="1091703"/>
            <a:ext cx="6858000" cy="572619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98C1D9A-4577-6EE2-4968-A830F11C4337}"/>
              </a:ext>
            </a:extLst>
          </p:cNvPr>
          <p:cNvSpPr txBox="1"/>
          <p:nvPr/>
        </p:nvSpPr>
        <p:spPr>
          <a:xfrm>
            <a:off x="0" y="3108080"/>
            <a:ext cx="1550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 segmenta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C2B1080-6F69-C5D8-A10E-5EE7AE1F8B3A}"/>
              </a:ext>
            </a:extLst>
          </p:cNvPr>
          <p:cNvSpPr txBox="1"/>
          <p:nvPr/>
        </p:nvSpPr>
        <p:spPr>
          <a:xfrm>
            <a:off x="0" y="5082209"/>
            <a:ext cx="1550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6D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chondria segmenta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A96DA2-3CEB-D1B8-8CD1-543A420BFCA2}"/>
              </a:ext>
            </a:extLst>
          </p:cNvPr>
          <p:cNvSpPr txBox="1"/>
          <p:nvPr/>
        </p:nvSpPr>
        <p:spPr>
          <a:xfrm>
            <a:off x="1550504" y="3108080"/>
            <a:ext cx="1550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6D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r>
              <a:rPr lang="en-US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R 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gmentat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046660E-7C11-2E74-C3F9-F88AF97FD9C9}"/>
              </a:ext>
            </a:extLst>
          </p:cNvPr>
          <p:cNvSpPr txBox="1"/>
          <p:nvPr/>
        </p:nvSpPr>
        <p:spPr>
          <a:xfrm>
            <a:off x="1614116" y="5110835"/>
            <a:ext cx="1550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C segmentat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E7BD4F3-3C44-9ACF-A433-1464293CF45E}"/>
              </a:ext>
            </a:extLst>
          </p:cNvPr>
          <p:cNvSpPr txBox="1"/>
          <p:nvPr/>
        </p:nvSpPr>
        <p:spPr>
          <a:xfrm>
            <a:off x="5364480" y="2175172"/>
            <a:ext cx="1550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C volum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70E53E-C7DA-9B38-C9A5-267E6E550567}"/>
              </a:ext>
            </a:extLst>
          </p:cNvPr>
          <p:cNvSpPr txBox="1"/>
          <p:nvPr/>
        </p:nvSpPr>
        <p:spPr>
          <a:xfrm>
            <a:off x="5451945" y="3954799"/>
            <a:ext cx="1550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C lengt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B29E415-7C07-F048-537E-5D25014E9EA0}"/>
              </a:ext>
            </a:extLst>
          </p:cNvPr>
          <p:cNvSpPr txBox="1"/>
          <p:nvPr/>
        </p:nvSpPr>
        <p:spPr>
          <a:xfrm>
            <a:off x="5364480" y="6361043"/>
            <a:ext cx="1550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C coverag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534D9B0-385B-CE8B-0B6E-161581590A5A}"/>
              </a:ext>
            </a:extLst>
          </p:cNvPr>
          <p:cNvSpPr txBox="1"/>
          <p:nvPr/>
        </p:nvSpPr>
        <p:spPr>
          <a:xfrm>
            <a:off x="3164620" y="3385079"/>
            <a:ext cx="1550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Cs paramete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EDE30C4-1331-CCD8-2306-F4892243B924}"/>
              </a:ext>
            </a:extLst>
          </p:cNvPr>
          <p:cNvSpPr txBox="1"/>
          <p:nvPr/>
        </p:nvSpPr>
        <p:spPr>
          <a:xfrm>
            <a:off x="208198" y="1345819"/>
            <a:ext cx="2117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94F635D-6D2C-B471-9983-1E7928965A06}"/>
              </a:ext>
            </a:extLst>
          </p:cNvPr>
          <p:cNvSpPr txBox="1"/>
          <p:nvPr/>
        </p:nvSpPr>
        <p:spPr>
          <a:xfrm>
            <a:off x="1550504" y="1345819"/>
            <a:ext cx="2117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(c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3597C87-3B7A-795E-52BB-6550A8A1426E}"/>
              </a:ext>
            </a:extLst>
          </p:cNvPr>
          <p:cNvSpPr txBox="1"/>
          <p:nvPr/>
        </p:nvSpPr>
        <p:spPr>
          <a:xfrm>
            <a:off x="208198" y="3663833"/>
            <a:ext cx="2117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(b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E7FDEF5-ACC3-0A08-755C-B60CC1B7C1E9}"/>
              </a:ext>
            </a:extLst>
          </p:cNvPr>
          <p:cNvSpPr txBox="1"/>
          <p:nvPr/>
        </p:nvSpPr>
        <p:spPr>
          <a:xfrm>
            <a:off x="1550504" y="3657726"/>
            <a:ext cx="2117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(d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C4A8225-0DB9-728C-71E3-D6BE5E9A1BFF}"/>
              </a:ext>
            </a:extLst>
          </p:cNvPr>
          <p:cNvSpPr txBox="1"/>
          <p:nvPr/>
        </p:nvSpPr>
        <p:spPr>
          <a:xfrm>
            <a:off x="3246922" y="1356833"/>
            <a:ext cx="2117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(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99F901E-DBBE-2BFD-7FD0-9644D07ADC25}"/>
              </a:ext>
            </a:extLst>
          </p:cNvPr>
          <p:cNvSpPr txBox="1"/>
          <p:nvPr/>
        </p:nvSpPr>
        <p:spPr>
          <a:xfrm>
            <a:off x="517585" y="414068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E7D11B-1E05-481C-5BB6-E6909B3C121D}"/>
              </a:ext>
            </a:extLst>
          </p:cNvPr>
          <p:cNvSpPr txBox="1"/>
          <p:nvPr/>
        </p:nvSpPr>
        <p:spPr>
          <a:xfrm>
            <a:off x="208199" y="7321127"/>
            <a:ext cx="639377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0" dirty="0"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4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ree-dimensional segmentation in Amira for MERCS identification. (a) Segmentation and 3D rendering of ER (yellow), mitochondria (b, green), and Mito-ER segmentation (c) to generate MERCS surfaces (d, pink). (e) Measuring MERCS morphology using label analysis measurements to determine volume, length, and MERCS coverage per mitochondrial perimeter.</a:t>
            </a:r>
            <a:r>
              <a:rPr lang="en-US" sz="1400" dirty="0"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 </a:t>
            </a:r>
            <a:endParaRPr lang="en-US" sz="1400" b="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5157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538</TotalTime>
  <Words>168</Words>
  <Application>Microsoft Macintosh PowerPoint</Application>
  <PresentationFormat>Letter Paper (8.5x11 in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es, Jessica D.</dc:creator>
  <cp:lastModifiedBy>Trushina, Eugenia, Ph.D.</cp:lastModifiedBy>
  <cp:revision>699</cp:revision>
  <cp:lastPrinted>2022-06-28T14:24:17Z</cp:lastPrinted>
  <dcterms:created xsi:type="dcterms:W3CDTF">2022-03-01T14:24:29Z</dcterms:created>
  <dcterms:modified xsi:type="dcterms:W3CDTF">2023-04-07T16:15:57Z</dcterms:modified>
</cp:coreProperties>
</file>